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7559675" cy="10439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0" d="100"/>
          <a:sy n="80" d="100"/>
        </p:scale>
        <p:origin x="-3120" y="-328"/>
      </p:cViewPr>
      <p:guideLst>
        <p:guide orient="horz" pos="328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DD1769-1182-49D1-9463-AC2113DF6D9A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1400" y="1143000"/>
            <a:ext cx="22352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E20C81-BF9E-4830-97B7-BF2FF1D142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3840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08486"/>
            <a:ext cx="6425724" cy="3634458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483102"/>
            <a:ext cx="5669756" cy="2520438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E3374-0B4E-4C0F-A85E-4E4AFB33B830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88D-CF84-4909-95E0-3896E5E080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66507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E3374-0B4E-4C0F-A85E-4E4AFB33B830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88D-CF84-4909-95E0-3896E5E080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71339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55801"/>
            <a:ext cx="1630055" cy="88469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55801"/>
            <a:ext cx="4795669" cy="88469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E3374-0B4E-4C0F-A85E-4E4AFB33B830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88D-CF84-4909-95E0-3896E5E080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9890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E3374-0B4E-4C0F-A85E-4E4AFB33B830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88D-CF84-4909-95E0-3896E5E080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7340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02603"/>
            <a:ext cx="6520220" cy="4342500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986185"/>
            <a:ext cx="6520220" cy="2283618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E3374-0B4E-4C0F-A85E-4E4AFB33B830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88D-CF84-4909-95E0-3896E5E080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7460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779007"/>
            <a:ext cx="3212862" cy="66237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779007"/>
            <a:ext cx="3212862" cy="66237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E3374-0B4E-4C0F-A85E-4E4AFB33B830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88D-CF84-4909-95E0-3896E5E080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3370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5804"/>
            <a:ext cx="6520220" cy="201780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559104"/>
            <a:ext cx="3198096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813281"/>
            <a:ext cx="3198096" cy="56087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559104"/>
            <a:ext cx="3213847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813281"/>
            <a:ext cx="3213847" cy="56087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E3374-0B4E-4C0F-A85E-4E4AFB33B830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88D-CF84-4909-95E0-3896E5E080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4147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E3374-0B4E-4C0F-A85E-4E4AFB33B830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88D-CF84-4909-95E0-3896E5E080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1100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E3374-0B4E-4C0F-A85E-4E4AFB33B830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88D-CF84-4909-95E0-3896E5E080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3723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03083"/>
            <a:ext cx="3827085" cy="7418740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E3374-0B4E-4C0F-A85E-4E4AFB33B830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88D-CF84-4909-95E0-3896E5E080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9512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03083"/>
            <a:ext cx="3827085" cy="7418740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3E3374-0B4E-4C0F-A85E-4E4AFB33B830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B188D-CF84-4909-95E0-3896E5E080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7450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55804"/>
            <a:ext cx="6520220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779007"/>
            <a:ext cx="6520220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3E3374-0B4E-4C0F-A85E-4E4AFB33B830}" type="datetimeFigureOut">
              <a:rPr lang="en-GB" smtClean="0"/>
              <a:t>08/12/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675780"/>
            <a:ext cx="2551390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4B188D-CF84-4909-95E0-3896E5E080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1149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0" Type="http://schemas.openxmlformats.org/officeDocument/2006/relationships/image" Target="../media/image10.png"/><Relationship Id="rId21" Type="http://schemas.microsoft.com/office/2007/relationships/hdphoto" Target="../media/hdphoto10.wdp"/><Relationship Id="rId22" Type="http://schemas.openxmlformats.org/officeDocument/2006/relationships/image" Target="../media/image11.png"/><Relationship Id="rId23" Type="http://schemas.microsoft.com/office/2007/relationships/hdphoto" Target="../media/hdphoto11.wdp"/><Relationship Id="rId24" Type="http://schemas.openxmlformats.org/officeDocument/2006/relationships/image" Target="../media/image12.png"/><Relationship Id="rId25" Type="http://schemas.microsoft.com/office/2007/relationships/hdphoto" Target="../media/hdphoto12.wdp"/><Relationship Id="rId26" Type="http://schemas.openxmlformats.org/officeDocument/2006/relationships/image" Target="../media/image13.png"/><Relationship Id="rId27" Type="http://schemas.microsoft.com/office/2007/relationships/hdphoto" Target="../media/hdphoto13.wdp"/><Relationship Id="rId28" Type="http://schemas.openxmlformats.org/officeDocument/2006/relationships/image" Target="../media/image14.png"/><Relationship Id="rId29" Type="http://schemas.microsoft.com/office/2007/relationships/hdphoto" Target="../media/hdphoto14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microsoft.com/office/2007/relationships/hdphoto" Target="../media/hdphoto1.wdp"/><Relationship Id="rId4" Type="http://schemas.openxmlformats.org/officeDocument/2006/relationships/image" Target="../media/image2.png"/><Relationship Id="rId5" Type="http://schemas.microsoft.com/office/2007/relationships/hdphoto" Target="../media/hdphoto2.wdp"/><Relationship Id="rId30" Type="http://schemas.openxmlformats.org/officeDocument/2006/relationships/image" Target="../media/image15.png"/><Relationship Id="rId31" Type="http://schemas.openxmlformats.org/officeDocument/2006/relationships/image" Target="../media/image16.png"/><Relationship Id="rId32" Type="http://schemas.openxmlformats.org/officeDocument/2006/relationships/image" Target="../media/image17.png"/><Relationship Id="rId9" Type="http://schemas.microsoft.com/office/2007/relationships/hdphoto" Target="../media/hdphoto4.wdp"/><Relationship Id="rId6" Type="http://schemas.openxmlformats.org/officeDocument/2006/relationships/image" Target="../media/image3.png"/><Relationship Id="rId7" Type="http://schemas.microsoft.com/office/2007/relationships/hdphoto" Target="../media/hdphoto3.wdp"/><Relationship Id="rId8" Type="http://schemas.openxmlformats.org/officeDocument/2006/relationships/image" Target="../media/image4.png"/><Relationship Id="rId33" Type="http://schemas.microsoft.com/office/2007/relationships/hdphoto" Target="../media/hdphoto15.wdp"/><Relationship Id="rId10" Type="http://schemas.openxmlformats.org/officeDocument/2006/relationships/image" Target="../media/image5.png"/><Relationship Id="rId11" Type="http://schemas.microsoft.com/office/2007/relationships/hdphoto" Target="../media/hdphoto5.wdp"/><Relationship Id="rId12" Type="http://schemas.openxmlformats.org/officeDocument/2006/relationships/image" Target="../media/image6.png"/><Relationship Id="rId13" Type="http://schemas.microsoft.com/office/2007/relationships/hdphoto" Target="../media/hdphoto6.wdp"/><Relationship Id="rId14" Type="http://schemas.openxmlformats.org/officeDocument/2006/relationships/image" Target="../media/image7.png"/><Relationship Id="rId15" Type="http://schemas.microsoft.com/office/2007/relationships/hdphoto" Target="../media/hdphoto7.wdp"/><Relationship Id="rId16" Type="http://schemas.openxmlformats.org/officeDocument/2006/relationships/image" Target="../media/image8.png"/><Relationship Id="rId17" Type="http://schemas.microsoft.com/office/2007/relationships/hdphoto" Target="../media/hdphoto8.wdp"/><Relationship Id="rId18" Type="http://schemas.openxmlformats.org/officeDocument/2006/relationships/image" Target="../media/image9.png"/><Relationship Id="rId19" Type="http://schemas.microsoft.com/office/2007/relationships/hdphoto" Target="../media/hdphoto9.wdp"/></Relationships>
</file>

<file path=ppt/slides/_rels/slide2.xml.rels><?xml version="1.0" encoding="UTF-8" standalone="yes"?>
<Relationships xmlns="http://schemas.openxmlformats.org/package/2006/relationships"><Relationship Id="rId9" Type="http://schemas.microsoft.com/office/2007/relationships/hdphoto" Target="../media/hdphoto19.wdp"/><Relationship Id="rId20" Type="http://schemas.openxmlformats.org/officeDocument/2006/relationships/image" Target="../media/image27.png"/><Relationship Id="rId21" Type="http://schemas.microsoft.com/office/2007/relationships/hdphoto" Target="../media/hdphoto25.wdp"/><Relationship Id="rId22" Type="http://schemas.openxmlformats.org/officeDocument/2006/relationships/image" Target="../media/image28.png"/><Relationship Id="rId23" Type="http://schemas.microsoft.com/office/2007/relationships/hdphoto" Target="../media/hdphoto26.wdp"/><Relationship Id="rId10" Type="http://schemas.openxmlformats.org/officeDocument/2006/relationships/image" Target="../media/image22.png"/><Relationship Id="rId11" Type="http://schemas.microsoft.com/office/2007/relationships/hdphoto" Target="../media/hdphoto20.wdp"/><Relationship Id="rId12" Type="http://schemas.openxmlformats.org/officeDocument/2006/relationships/image" Target="../media/image23.png"/><Relationship Id="rId13" Type="http://schemas.microsoft.com/office/2007/relationships/hdphoto" Target="../media/hdphoto21.wdp"/><Relationship Id="rId14" Type="http://schemas.openxmlformats.org/officeDocument/2006/relationships/image" Target="../media/image24.png"/><Relationship Id="rId15" Type="http://schemas.microsoft.com/office/2007/relationships/hdphoto" Target="../media/hdphoto22.wdp"/><Relationship Id="rId16" Type="http://schemas.openxmlformats.org/officeDocument/2006/relationships/image" Target="../media/image25.png"/><Relationship Id="rId17" Type="http://schemas.microsoft.com/office/2007/relationships/hdphoto" Target="../media/hdphoto23.wdp"/><Relationship Id="rId18" Type="http://schemas.openxmlformats.org/officeDocument/2006/relationships/image" Target="../media/image26.png"/><Relationship Id="rId19" Type="http://schemas.microsoft.com/office/2007/relationships/hdphoto" Target="../media/hdphoto24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8.png"/><Relationship Id="rId3" Type="http://schemas.microsoft.com/office/2007/relationships/hdphoto" Target="../media/hdphoto16.wdp"/><Relationship Id="rId4" Type="http://schemas.openxmlformats.org/officeDocument/2006/relationships/image" Target="../media/image19.png"/><Relationship Id="rId5" Type="http://schemas.microsoft.com/office/2007/relationships/hdphoto" Target="../media/hdphoto17.wdp"/><Relationship Id="rId6" Type="http://schemas.openxmlformats.org/officeDocument/2006/relationships/image" Target="../media/image20.png"/><Relationship Id="rId7" Type="http://schemas.microsoft.com/office/2007/relationships/hdphoto" Target="../media/hdphoto18.wdp"/><Relationship Id="rId8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D0B5B8F7-8522-4F4D-BE07-C556C3C202EF}"/>
              </a:ext>
            </a:extLst>
          </p:cNvPr>
          <p:cNvSpPr txBox="1"/>
          <p:nvPr/>
        </p:nvSpPr>
        <p:spPr>
          <a:xfrm>
            <a:off x="3267079" y="0"/>
            <a:ext cx="39004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5E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3AF7067C-3E06-40B9-9E51-1AB4AA2F81B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32856" y="1731367"/>
            <a:ext cx="1116000" cy="62996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C7C74536-B7C1-4157-BD48-30CD2E3F5B5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32856" y="2539723"/>
            <a:ext cx="1116000" cy="50741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44F22B0F-87CD-4000-B719-999A79D7611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32856" y="3183322"/>
            <a:ext cx="1116000" cy="66760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476935F2-468B-4322-B609-84E4F8C7DD2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32856" y="4000396"/>
            <a:ext cx="1116000" cy="61188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xmlns="" id="{8D848B33-16BD-47A6-9061-1BB462B72A1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32856" y="4740680"/>
            <a:ext cx="1116000" cy="725729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A8D86FA6-CA87-48FC-A875-6FAC03E9B069}"/>
              </a:ext>
            </a:extLst>
          </p:cNvPr>
          <p:cNvSpPr txBox="1"/>
          <p:nvPr/>
        </p:nvSpPr>
        <p:spPr>
          <a:xfrm>
            <a:off x="4591050" y="2019957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SCN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A86EAC1B-B240-4B1F-B865-A15FC1A545A2}"/>
              </a:ext>
            </a:extLst>
          </p:cNvPr>
          <p:cNvSpPr txBox="1"/>
          <p:nvPr/>
        </p:nvSpPr>
        <p:spPr>
          <a:xfrm>
            <a:off x="4591050" y="258669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BAFA9725-E5E3-4119-B177-687E23565FB9}"/>
              </a:ext>
            </a:extLst>
          </p:cNvPr>
          <p:cNvSpPr txBox="1"/>
          <p:nvPr/>
        </p:nvSpPr>
        <p:spPr>
          <a:xfrm>
            <a:off x="4591050" y="3386795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750E302B-DC36-4157-A6DE-1EFEEEC62585}"/>
              </a:ext>
            </a:extLst>
          </p:cNvPr>
          <p:cNvSpPr txBox="1"/>
          <p:nvPr/>
        </p:nvSpPr>
        <p:spPr>
          <a:xfrm>
            <a:off x="4591050" y="416784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NGFR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B1094CC7-CEE2-4840-983B-F0277B0FAB2F}"/>
              </a:ext>
            </a:extLst>
          </p:cNvPr>
          <p:cNvSpPr txBox="1"/>
          <p:nvPr/>
        </p:nvSpPr>
        <p:spPr>
          <a:xfrm>
            <a:off x="4591050" y="5006043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SP6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E7EB65BC-A9E8-40F5-BB8C-61B41B6432B4}"/>
              </a:ext>
            </a:extLst>
          </p:cNvPr>
          <p:cNvSpPr txBox="1"/>
          <p:nvPr/>
        </p:nvSpPr>
        <p:spPr>
          <a:xfrm>
            <a:off x="0" y="0"/>
            <a:ext cx="39004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5C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CE9102B0-F518-450E-9E61-B875FC28E0AC}"/>
              </a:ext>
            </a:extLst>
          </p:cNvPr>
          <p:cNvSpPr txBox="1"/>
          <p:nvPr/>
        </p:nvSpPr>
        <p:spPr>
          <a:xfrm rot="16200000">
            <a:off x="2914650" y="694146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EC1BA8F7-CA4C-4278-B07F-E6E21D1484CA}"/>
              </a:ext>
            </a:extLst>
          </p:cNvPr>
          <p:cNvSpPr txBox="1"/>
          <p:nvPr/>
        </p:nvSpPr>
        <p:spPr>
          <a:xfrm rot="16200000">
            <a:off x="3209925" y="717959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iFSCN1#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5186A18C-A9AC-4AA6-8228-984373AC06A9}"/>
              </a:ext>
            </a:extLst>
          </p:cNvPr>
          <p:cNvSpPr txBox="1"/>
          <p:nvPr/>
        </p:nvSpPr>
        <p:spPr>
          <a:xfrm rot="16200000">
            <a:off x="3505199" y="713198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iFSCN1#2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xmlns="" id="{31A885CF-B873-4F91-ACAC-74E35B48256C}"/>
              </a:ext>
            </a:extLst>
          </p:cNvPr>
          <p:cNvSpPr/>
          <p:nvPr/>
        </p:nvSpPr>
        <p:spPr>
          <a:xfrm>
            <a:off x="3781427" y="2015172"/>
            <a:ext cx="838200" cy="2762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xmlns="" id="{E45FDC9C-7D66-4B47-B40D-AAD3036249A3}"/>
              </a:ext>
            </a:extLst>
          </p:cNvPr>
          <p:cNvSpPr/>
          <p:nvPr/>
        </p:nvSpPr>
        <p:spPr>
          <a:xfrm>
            <a:off x="3820886" y="2600960"/>
            <a:ext cx="669471" cy="2068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xmlns="" id="{5AE2BDE1-43E7-4B87-B336-89A712B49932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3743" y="2375239"/>
            <a:ext cx="1116000" cy="454362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xmlns="" id="{06048B9E-9074-4024-8CF3-1E6F03F0AEF4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0114" y="2926510"/>
            <a:ext cx="1116000" cy="475333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xmlns="" id="{32B79F93-FD57-47D7-901C-EF4A3F791591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88483" y="3896223"/>
            <a:ext cx="1116000" cy="523224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xmlns="" id="{9B860418-D102-45C8-A811-7450E1DCD403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22377" y="5428955"/>
            <a:ext cx="1116000" cy="511222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xmlns="" id="{2BCE463F-87BF-4FD8-B5EA-8DE74118F652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1063" y="1371052"/>
            <a:ext cx="1116000" cy="490411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xmlns="" id="{8870539A-9F98-4FC3-A351-FC95AA94FC41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9730" y="1940560"/>
            <a:ext cx="1116000" cy="360680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6DC374B9-11AB-4AB4-BF3A-E5B39A40952E}"/>
              </a:ext>
            </a:extLst>
          </p:cNvPr>
          <p:cNvSpPr txBox="1"/>
          <p:nvPr/>
        </p:nvSpPr>
        <p:spPr>
          <a:xfrm>
            <a:off x="1479550" y="202662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DK2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C3228D19-03B6-49A4-B96D-9048C1A1EE76}"/>
              </a:ext>
            </a:extLst>
          </p:cNvPr>
          <p:cNvSpPr txBox="1"/>
          <p:nvPr/>
        </p:nvSpPr>
        <p:spPr>
          <a:xfrm>
            <a:off x="1492250" y="559532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SP6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A7E1A455-5177-4E69-8C03-81DABCA23AC1}"/>
              </a:ext>
            </a:extLst>
          </p:cNvPr>
          <p:cNvSpPr txBox="1"/>
          <p:nvPr/>
        </p:nvSpPr>
        <p:spPr>
          <a:xfrm>
            <a:off x="1466850" y="250922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27KIP1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xmlns="" id="{08F69FEE-C111-410F-9655-5DF48B7119FC}"/>
              </a:ext>
            </a:extLst>
          </p:cNvPr>
          <p:cNvSpPr txBox="1"/>
          <p:nvPr/>
        </p:nvSpPr>
        <p:spPr>
          <a:xfrm>
            <a:off x="1466850" y="404592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Rb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xmlns="" id="{205A77E4-3E75-4BA3-A942-9BABE3DEA293}"/>
              </a:ext>
            </a:extLst>
          </p:cNvPr>
          <p:cNvSpPr txBox="1"/>
          <p:nvPr/>
        </p:nvSpPr>
        <p:spPr>
          <a:xfrm>
            <a:off x="1416050" y="302992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xmlns="" id="{5136E59D-A464-45CE-956C-BB8DB911077C}"/>
              </a:ext>
            </a:extLst>
          </p:cNvPr>
          <p:cNvSpPr txBox="1"/>
          <p:nvPr/>
        </p:nvSpPr>
        <p:spPr>
          <a:xfrm>
            <a:off x="1555750" y="504922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E2F1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679AB033-48C0-4CFA-9C98-B220C386D58A}"/>
              </a:ext>
            </a:extLst>
          </p:cNvPr>
          <p:cNvSpPr txBox="1"/>
          <p:nvPr/>
        </p:nvSpPr>
        <p:spPr>
          <a:xfrm>
            <a:off x="1454150" y="149322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SCN1</a:t>
            </a:r>
          </a:p>
        </p:txBody>
      </p:sp>
      <p:pic>
        <p:nvPicPr>
          <p:cNvPr id="72" name="Picture 71">
            <a:extLst>
              <a:ext uri="{FF2B5EF4-FFF2-40B4-BE49-F238E27FC236}">
                <a16:creationId xmlns:a16="http://schemas.microsoft.com/office/drawing/2014/main" xmlns="" id="{50C64001-E40C-4BCA-B95F-E7C3DB7C2387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88331" y="3513811"/>
            <a:ext cx="1116000" cy="294793"/>
          </a:xfrm>
          <a:prstGeom prst="rect">
            <a:avLst/>
          </a:prstGeom>
        </p:spPr>
      </p:pic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D57811BE-68E9-485F-82D4-FA91B7D28DA6}"/>
              </a:ext>
            </a:extLst>
          </p:cNvPr>
          <p:cNvSpPr txBox="1"/>
          <p:nvPr/>
        </p:nvSpPr>
        <p:spPr>
          <a:xfrm>
            <a:off x="1441450" y="347442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CND1</a:t>
            </a:r>
          </a:p>
        </p:txBody>
      </p:sp>
      <p:pic>
        <p:nvPicPr>
          <p:cNvPr id="74" name="Picture 73">
            <a:extLst>
              <a:ext uri="{FF2B5EF4-FFF2-40B4-BE49-F238E27FC236}">
                <a16:creationId xmlns:a16="http://schemas.microsoft.com/office/drawing/2014/main" xmlns="" id="{9924766C-8001-48ED-8E37-7E98ED13B930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14698" y="4560781"/>
            <a:ext cx="1116000" cy="336411"/>
          </a:xfrm>
          <a:prstGeom prst="rect">
            <a:avLst/>
          </a:prstGeom>
        </p:spPr>
      </p:pic>
      <p:sp>
        <p:nvSpPr>
          <p:cNvPr id="75" name="TextBox 74">
            <a:extLst>
              <a:ext uri="{FF2B5EF4-FFF2-40B4-BE49-F238E27FC236}">
                <a16:creationId xmlns:a16="http://schemas.microsoft.com/office/drawing/2014/main" xmlns="" id="{CB08BC8F-0702-4F94-8610-9D0FCE863E28}"/>
              </a:ext>
            </a:extLst>
          </p:cNvPr>
          <p:cNvSpPr txBox="1"/>
          <p:nvPr/>
        </p:nvSpPr>
        <p:spPr>
          <a:xfrm>
            <a:off x="1479550" y="457932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xmlns="" id="{B93E641C-F81D-4D1B-817A-694C1B8093A0}"/>
              </a:ext>
            </a:extLst>
          </p:cNvPr>
          <p:cNvSpPr txBox="1"/>
          <p:nvPr/>
        </p:nvSpPr>
        <p:spPr>
          <a:xfrm rot="16200000">
            <a:off x="-377190" y="313146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xmlns="" id="{839744BC-FF5B-444B-96BF-CFB8513B131A}"/>
              </a:ext>
            </a:extLst>
          </p:cNvPr>
          <p:cNvSpPr txBox="1"/>
          <p:nvPr/>
        </p:nvSpPr>
        <p:spPr>
          <a:xfrm rot="16200000">
            <a:off x="-31115" y="336959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iFSCN1#1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xmlns="" id="{EF7E0D83-C4E1-49D3-8746-2C9AAD35496E}"/>
              </a:ext>
            </a:extLst>
          </p:cNvPr>
          <p:cNvSpPr txBox="1"/>
          <p:nvPr/>
        </p:nvSpPr>
        <p:spPr>
          <a:xfrm rot="16200000">
            <a:off x="289559" y="332198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iFSCN1#2</a:t>
            </a: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xmlns="" id="{C219E53A-FC0B-4D1C-AA18-4A0EB37F5429}"/>
              </a:ext>
            </a:extLst>
          </p:cNvPr>
          <p:cNvSpPr/>
          <p:nvPr/>
        </p:nvSpPr>
        <p:spPr>
          <a:xfrm>
            <a:off x="530227" y="2489305"/>
            <a:ext cx="838200" cy="22849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79E0AB18-3400-408F-9E61-C7C705677038}"/>
              </a:ext>
            </a:extLst>
          </p:cNvPr>
          <p:cNvSpPr txBox="1"/>
          <p:nvPr/>
        </p:nvSpPr>
        <p:spPr>
          <a:xfrm>
            <a:off x="0" y="6424612"/>
            <a:ext cx="39004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5D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8A879532-75CE-417C-80B7-6F4518C87D2B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246120" y="7393067"/>
            <a:ext cx="1440000" cy="1080000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1FFE0273-5B91-443E-AF6D-68030A326E8A}"/>
              </a:ext>
            </a:extLst>
          </p:cNvPr>
          <p:cNvSpPr txBox="1"/>
          <p:nvPr/>
        </p:nvSpPr>
        <p:spPr>
          <a:xfrm>
            <a:off x="171450" y="7102492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39EB594D-F542-4042-BCC4-0A9D65B4E838}"/>
              </a:ext>
            </a:extLst>
          </p:cNvPr>
          <p:cNvSpPr txBox="1"/>
          <p:nvPr/>
        </p:nvSpPr>
        <p:spPr>
          <a:xfrm>
            <a:off x="1680210" y="7072012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iFSCN1#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2901FA07-014F-49FD-AFA3-2270296C176C}"/>
              </a:ext>
            </a:extLst>
          </p:cNvPr>
          <p:cNvSpPr txBox="1"/>
          <p:nvPr/>
        </p:nvSpPr>
        <p:spPr>
          <a:xfrm>
            <a:off x="3173730" y="7102492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iFSCN1#2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C6CF83EF-37BF-4877-951E-49DB151F841B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1706880" y="7393067"/>
            <a:ext cx="1440000" cy="10800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xmlns="" id="{919299BF-8410-4297-8396-7B3AF5E22BB9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200025" y="7393067"/>
            <a:ext cx="1440000" cy="10800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xmlns="" id="{057429E4-4604-4E42-B085-47CFD593CAA1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-21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17512" y="5010150"/>
            <a:ext cx="1116000" cy="270000"/>
          </a:xfrm>
          <a:prstGeom prst="rect">
            <a:avLst/>
          </a:prstGeom>
        </p:spPr>
      </p:pic>
      <p:sp>
        <p:nvSpPr>
          <p:cNvPr id="56" name="Rectangle 55">
            <a:extLst>
              <a:ext uri="{FF2B5EF4-FFF2-40B4-BE49-F238E27FC236}">
                <a16:creationId xmlns:a16="http://schemas.microsoft.com/office/drawing/2014/main" xmlns="" id="{7B754832-70BB-479A-8198-FA4B0D1C61E9}"/>
              </a:ext>
            </a:extLst>
          </p:cNvPr>
          <p:cNvSpPr/>
          <p:nvPr/>
        </p:nvSpPr>
        <p:spPr>
          <a:xfrm>
            <a:off x="628650" y="5095875"/>
            <a:ext cx="806452" cy="1746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81382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TextBox 78">
            <a:extLst>
              <a:ext uri="{FF2B5EF4-FFF2-40B4-BE49-F238E27FC236}">
                <a16:creationId xmlns:a16="http://schemas.microsoft.com/office/drawing/2014/main" xmlns="" id="{555856F9-E5DD-4C77-BF06-4C9BDC05A382}"/>
              </a:ext>
            </a:extLst>
          </p:cNvPr>
          <p:cNvSpPr txBox="1"/>
          <p:nvPr/>
        </p:nvSpPr>
        <p:spPr>
          <a:xfrm>
            <a:off x="0" y="0"/>
            <a:ext cx="39004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5G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xmlns="" id="{F2D19F61-71B0-453D-B23F-466AC4D46B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9560" y="1345983"/>
            <a:ext cx="1116000" cy="505254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xmlns="" id="{D74E42A7-181E-4B8A-BE1F-5E770C2ED68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9560" y="1982673"/>
            <a:ext cx="1116000" cy="476160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xmlns="" id="{CB60922F-E39C-4FBB-B476-B1CB97D4A84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9560" y="2640361"/>
            <a:ext cx="1116000" cy="468444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xmlns="" id="{BB160621-601E-4B6F-B6BD-114DD799DF5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9560" y="3255046"/>
            <a:ext cx="1116000" cy="497201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xmlns="" id="{8EA57837-2770-45A9-A030-F03314A22181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9560" y="3882924"/>
            <a:ext cx="1116000" cy="384362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xmlns="" id="{513340F3-6C84-4D40-958F-FBA1796AE367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9560" y="4423797"/>
            <a:ext cx="1116000" cy="408293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FC9FB962-45F3-4677-8B1C-F0A37324C6FE}"/>
              </a:ext>
            </a:extLst>
          </p:cNvPr>
          <p:cNvSpPr txBox="1"/>
          <p:nvPr/>
        </p:nvSpPr>
        <p:spPr>
          <a:xfrm rot="16200000">
            <a:off x="-1005840" y="-372860"/>
            <a:ext cx="31248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Lenti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-Ctrl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xmlns="" id="{10CFCFED-4572-4817-A0BC-595C152822BF}"/>
              </a:ext>
            </a:extLst>
          </p:cNvPr>
          <p:cNvSpPr txBox="1"/>
          <p:nvPr/>
        </p:nvSpPr>
        <p:spPr>
          <a:xfrm rot="16200000">
            <a:off x="-533400" y="-372860"/>
            <a:ext cx="31248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Lenti-FSCN1</a:t>
            </a:r>
          </a:p>
        </p:txBody>
      </p:sp>
      <p:pic>
        <p:nvPicPr>
          <p:cNvPr id="81" name="Picture 80">
            <a:extLst>
              <a:ext uri="{FF2B5EF4-FFF2-40B4-BE49-F238E27FC236}">
                <a16:creationId xmlns:a16="http://schemas.microsoft.com/office/drawing/2014/main" xmlns="" id="{4DFEE236-03A4-4424-8BE6-72594AD97F31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612353" y="1269444"/>
            <a:ext cx="1116000" cy="708758"/>
          </a:xfrm>
          <a:prstGeom prst="rect">
            <a:avLst/>
          </a:prstGeom>
        </p:spPr>
      </p:pic>
      <p:pic>
        <p:nvPicPr>
          <p:cNvPr id="82" name="Picture 81">
            <a:extLst>
              <a:ext uri="{FF2B5EF4-FFF2-40B4-BE49-F238E27FC236}">
                <a16:creationId xmlns:a16="http://schemas.microsoft.com/office/drawing/2014/main" xmlns="" id="{22BE8688-05E3-4AE2-8D0F-9394CCA1431F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612353" y="2061883"/>
            <a:ext cx="1116000" cy="856110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xmlns="" id="{7255B0F0-D10D-4D88-8BED-3F1F6FC13B49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612353" y="3031165"/>
            <a:ext cx="1116000" cy="753370"/>
          </a:xfrm>
          <a:prstGeom prst="rect">
            <a:avLst/>
          </a:prstGeom>
        </p:spPr>
      </p:pic>
      <p:pic>
        <p:nvPicPr>
          <p:cNvPr id="84" name="Picture 83">
            <a:extLst>
              <a:ext uri="{FF2B5EF4-FFF2-40B4-BE49-F238E27FC236}">
                <a16:creationId xmlns:a16="http://schemas.microsoft.com/office/drawing/2014/main" xmlns="" id="{7D2ADCF9-8D42-4F71-8CBE-34DC1015E3C9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612353" y="3884593"/>
            <a:ext cx="1116000" cy="547505"/>
          </a:xfrm>
          <a:prstGeom prst="rect">
            <a:avLst/>
          </a:prstGeom>
        </p:spPr>
      </p:pic>
      <p:pic>
        <p:nvPicPr>
          <p:cNvPr id="85" name="Picture 84">
            <a:extLst>
              <a:ext uri="{FF2B5EF4-FFF2-40B4-BE49-F238E27FC236}">
                <a16:creationId xmlns:a16="http://schemas.microsoft.com/office/drawing/2014/main" xmlns="" id="{9A3D9EBD-9B76-4501-A650-3E2E523A23D1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612353" y="4573494"/>
            <a:ext cx="1116000" cy="345429"/>
          </a:xfrm>
          <a:prstGeom prst="rect">
            <a:avLst/>
          </a:prstGeom>
        </p:spPr>
      </p:pic>
      <p:sp>
        <p:nvSpPr>
          <p:cNvPr id="86" name="TextBox 85">
            <a:extLst>
              <a:ext uri="{FF2B5EF4-FFF2-40B4-BE49-F238E27FC236}">
                <a16:creationId xmlns:a16="http://schemas.microsoft.com/office/drawing/2014/main" xmlns="" id="{7C9715B8-0EBA-46D7-AF4E-EBEFA8AAFCCD}"/>
              </a:ext>
            </a:extLst>
          </p:cNvPr>
          <p:cNvSpPr txBox="1"/>
          <p:nvPr/>
        </p:nvSpPr>
        <p:spPr>
          <a:xfrm rot="16200000">
            <a:off x="1280160" y="-388100"/>
            <a:ext cx="31248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Lenti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-Ctrl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xmlns="" id="{3402173C-5D33-4C23-BE7F-5B9D8D1567A4}"/>
              </a:ext>
            </a:extLst>
          </p:cNvPr>
          <p:cNvSpPr txBox="1"/>
          <p:nvPr/>
        </p:nvSpPr>
        <p:spPr>
          <a:xfrm rot="16200000">
            <a:off x="1752600" y="-388100"/>
            <a:ext cx="31248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Lenti-FSCN1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xmlns="" id="{EA00B22E-30CF-4EA7-BD7B-D2C48B3F0346}"/>
              </a:ext>
            </a:extLst>
          </p:cNvPr>
          <p:cNvSpPr txBox="1"/>
          <p:nvPr/>
        </p:nvSpPr>
        <p:spPr>
          <a:xfrm>
            <a:off x="1362710" y="149322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SCN1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xmlns="" id="{295B21B4-0EF8-4DC9-9CEC-0C9403C887B3}"/>
              </a:ext>
            </a:extLst>
          </p:cNvPr>
          <p:cNvSpPr txBox="1"/>
          <p:nvPr/>
        </p:nvSpPr>
        <p:spPr>
          <a:xfrm>
            <a:off x="1362710" y="208758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XL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xmlns="" id="{4595EEC1-7B02-4F02-BAD9-B26361F9FC5D}"/>
              </a:ext>
            </a:extLst>
          </p:cNvPr>
          <p:cNvSpPr txBox="1"/>
          <p:nvPr/>
        </p:nvSpPr>
        <p:spPr>
          <a:xfrm>
            <a:off x="1362710" y="272766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xmlns="" id="{8F7CFEEF-AC3B-49CE-A724-B0E901EA042D}"/>
              </a:ext>
            </a:extLst>
          </p:cNvPr>
          <p:cNvSpPr txBox="1"/>
          <p:nvPr/>
        </p:nvSpPr>
        <p:spPr>
          <a:xfrm>
            <a:off x="1362710" y="335250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OX1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xmlns="" id="{3DF130F0-A3D4-4589-8C33-448FFF0B1A62}"/>
              </a:ext>
            </a:extLst>
          </p:cNvPr>
          <p:cNvSpPr txBox="1"/>
          <p:nvPr/>
        </p:nvSpPr>
        <p:spPr>
          <a:xfrm>
            <a:off x="1362710" y="399258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OX9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xmlns="" id="{597C122F-B0FD-4BB8-B841-41166EA142E3}"/>
              </a:ext>
            </a:extLst>
          </p:cNvPr>
          <p:cNvSpPr txBox="1"/>
          <p:nvPr/>
        </p:nvSpPr>
        <p:spPr>
          <a:xfrm>
            <a:off x="1362710" y="448026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xmlns="" id="{736F4456-D4DE-43D1-A899-5662303D209C}"/>
              </a:ext>
            </a:extLst>
          </p:cNvPr>
          <p:cNvSpPr txBox="1"/>
          <p:nvPr/>
        </p:nvSpPr>
        <p:spPr>
          <a:xfrm>
            <a:off x="3679190" y="460218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xmlns="" id="{2F2E228A-F5B2-4E5D-AA4B-8D2B0CF3AE41}"/>
              </a:ext>
            </a:extLst>
          </p:cNvPr>
          <p:cNvSpPr txBox="1"/>
          <p:nvPr/>
        </p:nvSpPr>
        <p:spPr>
          <a:xfrm>
            <a:off x="3679190" y="406878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LOXL2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xmlns="" id="{7F80A772-BBE0-4AD6-A58E-3446DC53E553}"/>
              </a:ext>
            </a:extLst>
          </p:cNvPr>
          <p:cNvSpPr txBox="1"/>
          <p:nvPr/>
        </p:nvSpPr>
        <p:spPr>
          <a:xfrm>
            <a:off x="3679190" y="330678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NC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xmlns="" id="{A73CE0DD-B61C-42FA-9D42-08A83C21EFFA}"/>
              </a:ext>
            </a:extLst>
          </p:cNvPr>
          <p:cNvSpPr txBox="1"/>
          <p:nvPr/>
        </p:nvSpPr>
        <p:spPr>
          <a:xfrm>
            <a:off x="3679190" y="146274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FN1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xmlns="" id="{84EF87CF-A933-4EC8-A5FC-01AE5A684C8A}"/>
              </a:ext>
            </a:extLst>
          </p:cNvPr>
          <p:cNvSpPr txBox="1"/>
          <p:nvPr/>
        </p:nvSpPr>
        <p:spPr>
          <a:xfrm>
            <a:off x="3679190" y="2407624"/>
            <a:ext cx="1857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HBS1</a:t>
            </a:r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xmlns="" id="{32476C5D-7167-4F0E-9547-B1817B776A28}"/>
              </a:ext>
            </a:extLst>
          </p:cNvPr>
          <p:cNvSpPr/>
          <p:nvPr/>
        </p:nvSpPr>
        <p:spPr>
          <a:xfrm>
            <a:off x="365760" y="3286760"/>
            <a:ext cx="924197" cy="2184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xmlns="" id="{DCC20D7A-3302-4607-B38F-4FB0BCC17C63}"/>
              </a:ext>
            </a:extLst>
          </p:cNvPr>
          <p:cNvSpPr/>
          <p:nvPr/>
        </p:nvSpPr>
        <p:spPr>
          <a:xfrm>
            <a:off x="655321" y="3972560"/>
            <a:ext cx="670560" cy="2794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11934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6</Words>
  <Application>Microsoft Macintosh PowerPoint</Application>
  <PresentationFormat>Personnalisé</PresentationFormat>
  <Paragraphs>42</Paragraphs>
  <Slides>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Office Theme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ena.diazzi1@gmail.com</dc:creator>
  <cp:lastModifiedBy>Sophie Tartare-Deckert</cp:lastModifiedBy>
  <cp:revision>17</cp:revision>
  <dcterms:created xsi:type="dcterms:W3CDTF">2021-12-01T21:45:06Z</dcterms:created>
  <dcterms:modified xsi:type="dcterms:W3CDTF">2021-12-08T08:52:27Z</dcterms:modified>
</cp:coreProperties>
</file>